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669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102" y="4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91FC0-12D9-4570-A118-E01BE23E5644}" type="datetimeFigureOut">
              <a:rPr lang="fr-FR" smtClean="0"/>
              <a:t>24/07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CD5E4-853A-4A55-87CC-29711ABDCC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912311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91FC0-12D9-4570-A118-E01BE23E5644}" type="datetimeFigureOut">
              <a:rPr lang="fr-FR" smtClean="0"/>
              <a:t>24/07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CD5E4-853A-4A55-87CC-29711ABDCC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5273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91FC0-12D9-4570-A118-E01BE23E5644}" type="datetimeFigureOut">
              <a:rPr lang="fr-FR" smtClean="0"/>
              <a:t>24/07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CD5E4-853A-4A55-87CC-29711ABDCC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72288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91FC0-12D9-4570-A118-E01BE23E5644}" type="datetimeFigureOut">
              <a:rPr lang="fr-FR" smtClean="0"/>
              <a:t>24/07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CD5E4-853A-4A55-87CC-29711ABDCC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09190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91FC0-12D9-4570-A118-E01BE23E5644}" type="datetimeFigureOut">
              <a:rPr lang="fr-FR" smtClean="0"/>
              <a:t>24/07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CD5E4-853A-4A55-87CC-29711ABDCC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75924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91FC0-12D9-4570-A118-E01BE23E5644}" type="datetimeFigureOut">
              <a:rPr lang="fr-FR" smtClean="0"/>
              <a:t>24/07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CD5E4-853A-4A55-87CC-29711ABDCC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9306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91FC0-12D9-4570-A118-E01BE23E5644}" type="datetimeFigureOut">
              <a:rPr lang="fr-FR" smtClean="0"/>
              <a:t>24/07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CD5E4-853A-4A55-87CC-29711ABDCC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41870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91FC0-12D9-4570-A118-E01BE23E5644}" type="datetimeFigureOut">
              <a:rPr lang="fr-FR" smtClean="0"/>
              <a:t>24/07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CD5E4-853A-4A55-87CC-29711ABDCC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38009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91FC0-12D9-4570-A118-E01BE23E5644}" type="datetimeFigureOut">
              <a:rPr lang="fr-FR" smtClean="0"/>
              <a:t>24/07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CD5E4-853A-4A55-87CC-29711ABDCC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20982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91FC0-12D9-4570-A118-E01BE23E5644}" type="datetimeFigureOut">
              <a:rPr lang="fr-FR" smtClean="0"/>
              <a:t>24/07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CD5E4-853A-4A55-87CC-29711ABDCC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46569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91FC0-12D9-4570-A118-E01BE23E5644}" type="datetimeFigureOut">
              <a:rPr lang="fr-FR" smtClean="0"/>
              <a:t>24/07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CD5E4-853A-4A55-87CC-29711ABDCC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02508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791FC0-12D9-4570-A118-E01BE23E5644}" type="datetimeFigureOut">
              <a:rPr lang="fr-FR" smtClean="0"/>
              <a:t>24/07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1CD5E4-853A-4A55-87CC-29711ABDCC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81919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au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36495427"/>
              </p:ext>
            </p:extLst>
          </p:nvPr>
        </p:nvGraphicFramePr>
        <p:xfrm>
          <a:off x="1410937" y="160429"/>
          <a:ext cx="9257061" cy="6452222"/>
        </p:xfrm>
        <a:graphic>
          <a:graphicData uri="http://schemas.openxmlformats.org/drawingml/2006/table">
            <a:tbl>
              <a:tblPr firstRow="1" firstCol="1" bandRow="1"/>
              <a:tblGrid>
                <a:gridCol w="616975">
                  <a:extLst>
                    <a:ext uri="{9D8B030D-6E8A-4147-A177-3AD203B41FA5}">
                      <a16:colId xmlns:a16="http://schemas.microsoft.com/office/drawing/2014/main" val="1615003794"/>
                    </a:ext>
                  </a:extLst>
                </a:gridCol>
                <a:gridCol w="1009543">
                  <a:extLst>
                    <a:ext uri="{9D8B030D-6E8A-4147-A177-3AD203B41FA5}">
                      <a16:colId xmlns:a16="http://schemas.microsoft.com/office/drawing/2014/main" val="1715057865"/>
                    </a:ext>
                  </a:extLst>
                </a:gridCol>
                <a:gridCol w="771220">
                  <a:extLst>
                    <a:ext uri="{9D8B030D-6E8A-4147-A177-3AD203B41FA5}">
                      <a16:colId xmlns:a16="http://schemas.microsoft.com/office/drawing/2014/main" val="4049422827"/>
                    </a:ext>
                  </a:extLst>
                </a:gridCol>
                <a:gridCol w="771825">
                  <a:extLst>
                    <a:ext uri="{9D8B030D-6E8A-4147-A177-3AD203B41FA5}">
                      <a16:colId xmlns:a16="http://schemas.microsoft.com/office/drawing/2014/main" val="686421464"/>
                    </a:ext>
                  </a:extLst>
                </a:gridCol>
                <a:gridCol w="771825">
                  <a:extLst>
                    <a:ext uri="{9D8B030D-6E8A-4147-A177-3AD203B41FA5}">
                      <a16:colId xmlns:a16="http://schemas.microsoft.com/office/drawing/2014/main" val="3482481061"/>
                    </a:ext>
                  </a:extLst>
                </a:gridCol>
                <a:gridCol w="771825">
                  <a:extLst>
                    <a:ext uri="{9D8B030D-6E8A-4147-A177-3AD203B41FA5}">
                      <a16:colId xmlns:a16="http://schemas.microsoft.com/office/drawing/2014/main" val="943263819"/>
                    </a:ext>
                  </a:extLst>
                </a:gridCol>
                <a:gridCol w="943005">
                  <a:extLst>
                    <a:ext uri="{9D8B030D-6E8A-4147-A177-3AD203B41FA5}">
                      <a16:colId xmlns:a16="http://schemas.microsoft.com/office/drawing/2014/main" val="4069128917"/>
                    </a:ext>
                  </a:extLst>
                </a:gridCol>
                <a:gridCol w="857114">
                  <a:extLst>
                    <a:ext uri="{9D8B030D-6E8A-4147-A177-3AD203B41FA5}">
                      <a16:colId xmlns:a16="http://schemas.microsoft.com/office/drawing/2014/main" val="2239727391"/>
                    </a:ext>
                  </a:extLst>
                </a:gridCol>
                <a:gridCol w="857718">
                  <a:extLst>
                    <a:ext uri="{9D8B030D-6E8A-4147-A177-3AD203B41FA5}">
                      <a16:colId xmlns:a16="http://schemas.microsoft.com/office/drawing/2014/main" val="1774720812"/>
                    </a:ext>
                  </a:extLst>
                </a:gridCol>
                <a:gridCol w="1886011">
                  <a:extLst>
                    <a:ext uri="{9D8B030D-6E8A-4147-A177-3AD203B41FA5}">
                      <a16:colId xmlns:a16="http://schemas.microsoft.com/office/drawing/2014/main" val="926439125"/>
                    </a:ext>
                  </a:extLst>
                </a:gridCol>
              </a:tblGrid>
              <a:tr h="205712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G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G somatic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G visceral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G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VG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NG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JG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RG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eference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5651728"/>
                  </a:ext>
                </a:extLst>
              </a:tr>
              <a:tr h="205712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ya1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.D.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 E9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1.5 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 E8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6.5 &lt; 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 E9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.D.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l-NL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hmed </a:t>
                      </a:r>
                      <a:r>
                        <a:rPr lang="nl-NL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t al., 2012; </a:t>
                      </a:r>
                      <a:r>
                        <a:rPr lang="nl-NL" sz="9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onishi</a:t>
                      </a:r>
                      <a:r>
                        <a:rPr lang="nl-NL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t al., 2006; </a:t>
                      </a:r>
                      <a:r>
                        <a:rPr lang="nl-NL" sz="9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Xu</a:t>
                      </a:r>
                      <a:r>
                        <a:rPr lang="nl-NL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t al., 1997; </a:t>
                      </a:r>
                      <a:r>
                        <a:rPr lang="nl-NL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Zou </a:t>
                      </a:r>
                      <a:r>
                        <a:rPr lang="nl-NL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t al., </a:t>
                      </a:r>
                      <a:r>
                        <a:rPr lang="nl-NL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04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6304530"/>
                  </a:ext>
                </a:extLst>
              </a:tr>
              <a:tr h="205712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ya2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1.5 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1.5 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1.5 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1.5 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0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07991055"/>
                  </a:ext>
                </a:extLst>
              </a:tr>
              <a:tr h="205712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ix1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8.5 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1.5 ?</a:t>
                      </a:r>
                      <a:endParaRPr lang="fr-FR" sz="1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F3864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 E9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8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5.5 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 E9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 E11 ?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0 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F3864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57570634"/>
                  </a:ext>
                </a:extLst>
              </a:tr>
              <a:tr h="205712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eurog2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9.5 (weak)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8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0.25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0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8.7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0.5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hmed 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t al., 2012; </a:t>
                      </a:r>
                      <a:r>
                        <a:rPr lang="fr-BE" sz="9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ode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t al., 1998; Ma et al., 1998, 1999; </a:t>
                      </a:r>
                      <a:r>
                        <a:rPr lang="fr-BE" sz="9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Ventéo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t al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., </a:t>
                      </a:r>
                      <a:r>
                        <a:rPr lang="fr-BE" sz="90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19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8438881"/>
                  </a:ext>
                </a:extLst>
              </a:tr>
              <a:tr h="310746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eurog1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8.2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0.5 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9.5 (weak)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0.5 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de-D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9.5 (weak in PG)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0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1.5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3.5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01949017"/>
                  </a:ext>
                </a:extLst>
              </a:tr>
              <a:tr h="205712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euroD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8.7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0.5 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0.5 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8.7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6.5 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&lt; ? &lt;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0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3.5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6400752"/>
                  </a:ext>
                </a:extLst>
              </a:tr>
              <a:tr h="205712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hox2a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8D08D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8D08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 err="1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ode</a:t>
                      </a:r>
                      <a:r>
                        <a:rPr lang="fr-BE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t al., 1998; </a:t>
                      </a:r>
                      <a:r>
                        <a:rPr lang="fr-BE" sz="9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attyn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t al., 1997; </a:t>
                      </a:r>
                      <a:r>
                        <a:rPr lang="fr-BE" sz="9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iveron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t al., </a:t>
                      </a:r>
                      <a:r>
                        <a:rPr lang="fr-BE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996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5184304"/>
                  </a:ext>
                </a:extLst>
              </a:tr>
              <a:tr h="310746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hox2b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8D08D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 (E16.5 PG)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8D08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47890845"/>
                  </a:ext>
                </a:extLst>
              </a:tr>
              <a:tr h="310746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dm12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0.5 &lt; 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AD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0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l-NL" sz="900" dirty="0" err="1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artesaghi</a:t>
                      </a:r>
                      <a:r>
                        <a:rPr lang="nl-NL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nl-NL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t al., 2019; Desiderio et al., 2019; </a:t>
                      </a:r>
                      <a:r>
                        <a:rPr lang="nl-NL" sz="9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inameri</a:t>
                      </a:r>
                      <a:r>
                        <a:rPr lang="nl-NL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t al., </a:t>
                      </a:r>
                      <a:r>
                        <a:rPr lang="nl-NL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08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8130498"/>
                  </a:ext>
                </a:extLst>
              </a:tr>
              <a:tr h="205712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slet1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 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F386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F386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8D08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AD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AD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8D08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0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F3864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l-NL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un </a:t>
                      </a:r>
                      <a:r>
                        <a:rPr lang="nl-NL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t al., 2008; </a:t>
                      </a:r>
                      <a:r>
                        <a:rPr lang="nl-NL" sz="9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akano-Maruyama</a:t>
                      </a:r>
                      <a:r>
                        <a:rPr lang="nl-NL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t al., 2012; </a:t>
                      </a:r>
                      <a:r>
                        <a:rPr lang="nl-NL" sz="9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haler</a:t>
                      </a:r>
                      <a:r>
                        <a:rPr lang="nl-NL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t al., </a:t>
                      </a:r>
                      <a:r>
                        <a:rPr lang="nl-NL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04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2485613"/>
                  </a:ext>
                </a:extLst>
              </a:tr>
              <a:tr h="260408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slet2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? &lt; E13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?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? &lt; E13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? &lt; E12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46924770"/>
                  </a:ext>
                </a:extLst>
              </a:tr>
              <a:tr h="598382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rn3a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 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F386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F386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AD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AD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?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0.5 ?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F3864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err="1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adea</a:t>
                      </a:r>
                      <a:r>
                        <a:rPr lang="en-US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t al., 2012; </a:t>
                      </a:r>
                      <a:r>
                        <a:rPr lang="en-US" sz="9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’Autréaux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t al., 2011; Dykes et al., 2010; </a:t>
                      </a:r>
                      <a:r>
                        <a:rPr lang="en-US" sz="9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edtsova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&amp; Turner, 1995; Huang et al., 2001; </a:t>
                      </a:r>
                      <a:r>
                        <a:rPr lang="en-US" sz="9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ajgo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t al., 2016; Sherrill et al., 2019; </a:t>
                      </a:r>
                      <a:r>
                        <a:rPr lang="en-US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Zou 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t al., </a:t>
                      </a:r>
                      <a:r>
                        <a:rPr lang="en-US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12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8654174"/>
                  </a:ext>
                </a:extLst>
              </a:tr>
              <a:tr h="33385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rn3b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? &lt; E12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~E12.5 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~E12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~E12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7.5 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3.5 ?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0.5 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F3864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28690343"/>
                  </a:ext>
                </a:extLst>
              </a:tr>
              <a:tr h="205712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lf7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1.5 &lt; 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0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0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1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0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err="1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aub</a:t>
                      </a:r>
                      <a:r>
                        <a:rPr lang="en-US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t al., </a:t>
                      </a:r>
                      <a:r>
                        <a:rPr lang="en-US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01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2570502"/>
                  </a:ext>
                </a:extLst>
              </a:tr>
              <a:tr h="205712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lx3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 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?</a:t>
                      </a:r>
                      <a:endParaRPr lang="fr-FR" sz="1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F386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 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?</a:t>
                      </a:r>
                      <a:endParaRPr lang="fr-FR" sz="1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F386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8D08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E12.5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AD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E16 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AD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8D08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0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 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F386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ondo 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t al., </a:t>
                      </a:r>
                      <a:r>
                        <a:rPr lang="en-US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08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2269270"/>
                  </a:ext>
                </a:extLst>
              </a:tr>
              <a:tr h="460433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unx1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~E11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.D.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1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AD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1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AD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?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? &lt; E13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2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3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hen </a:t>
                      </a:r>
                      <a:r>
                        <a:rPr lang="fr-BE" sz="9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t al., 2006; D’</a:t>
                      </a:r>
                      <a:r>
                        <a:rPr lang="fr-BE" sz="9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utréaux</a:t>
                      </a:r>
                      <a:r>
                        <a:rPr lang="fr-BE" sz="9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t al., 2011; Dykes et al., 2010; </a:t>
                      </a:r>
                      <a:r>
                        <a:rPr lang="fr-BE" sz="9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evanon</a:t>
                      </a:r>
                      <a:r>
                        <a:rPr lang="fr-BE" sz="9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t al., 2001, 2002; Lu et al., 2011; </a:t>
                      </a:r>
                      <a:r>
                        <a:rPr lang="fr-BE" sz="9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heriault</a:t>
                      </a:r>
                      <a:r>
                        <a:rPr lang="fr-BE" sz="9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t al., </a:t>
                      </a:r>
                      <a:r>
                        <a:rPr lang="fr-BE" sz="9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04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3553214"/>
                  </a:ext>
                </a:extLst>
              </a:tr>
              <a:tr h="205712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unx3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~E10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AD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0.5 &lt; ? &lt;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0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ADB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35763473"/>
                  </a:ext>
                </a:extLst>
              </a:tr>
              <a:tr h="310746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mx1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0.5 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3.5 ?</a:t>
                      </a:r>
                      <a:endParaRPr lang="fr-FR" sz="1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F386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0.5 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4.5 ?</a:t>
                      </a:r>
                      <a:endParaRPr lang="fr-FR" sz="1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F386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0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3.5 ?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ADB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0.5 &lt; ? &lt; 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0.5 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3.5?</a:t>
                      </a:r>
                      <a:endParaRPr lang="fr-FR" sz="1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F386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 err="1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Quina</a:t>
                      </a:r>
                      <a:r>
                        <a:rPr lang="fr-BE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t al., 2012; Wang et al., </a:t>
                      </a:r>
                      <a:r>
                        <a:rPr lang="fr-BE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00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7873652"/>
                  </a:ext>
                </a:extLst>
              </a:tr>
              <a:tr h="310746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hox2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0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3.5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0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2.5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0.5 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AD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err="1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bdo</a:t>
                      </a:r>
                      <a:r>
                        <a:rPr lang="en-US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t al., 2011; Rosin et al., 2015; Scott et al., </a:t>
                      </a:r>
                      <a:r>
                        <a:rPr lang="en-US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11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4223991"/>
                  </a:ext>
                </a:extLst>
              </a:tr>
              <a:tr h="310746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ata3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AD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16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AD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u 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t al., 2011; </a:t>
                      </a:r>
                      <a:r>
                        <a:rPr lang="fr-BE" sz="9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uo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t al., 2013; </a:t>
                      </a:r>
                      <a:r>
                        <a:rPr lang="fr-BE" sz="9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ardelli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t al., </a:t>
                      </a:r>
                      <a:r>
                        <a:rPr lang="fr-BE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999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6263106"/>
                  </a:ext>
                </a:extLst>
              </a:tr>
              <a:tr h="205712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x2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.D.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&lt; ? &lt;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9.5 &lt; ? &lt; ∞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61340" algn="ctr"/>
                        </a:tabLst>
                      </a:pPr>
                      <a:r>
                        <a:rPr lang="en-US" sz="900" dirty="0" err="1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ishijima</a:t>
                      </a:r>
                      <a:r>
                        <a:rPr lang="en-US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amp; </a:t>
                      </a:r>
                      <a:r>
                        <a:rPr lang="en-US" sz="9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Ohtoshi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, </a:t>
                      </a:r>
                      <a:r>
                        <a:rPr lang="en-US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06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3829255"/>
                  </a:ext>
                </a:extLst>
              </a:tr>
              <a:tr h="205712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</a:t>
                      </a:r>
                      <a:r>
                        <a:rPr lang="fr-BE" sz="900" b="1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r>
                        <a:rPr lang="fr-BE" sz="900" b="1" dirty="0" err="1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f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N.D.</a:t>
                      </a:r>
                      <a:endParaRPr lang="fr-FR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.D.</a:t>
                      </a:r>
                      <a:endParaRPr lang="fr-FR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.D.</a:t>
                      </a:r>
                      <a:endParaRPr lang="fr-FR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? 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.D. </a:t>
                      </a:r>
                      <a:endParaRPr lang="fr-FR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?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? 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~E10.5 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 ?</a:t>
                      </a:r>
                      <a:endParaRPr lang="fr-FR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 err="1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ourane</a:t>
                      </a:r>
                      <a:r>
                        <a:rPr lang="fr-BE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t al., 2009; </a:t>
                      </a:r>
                      <a:r>
                        <a:rPr lang="fr-BE" sz="9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upari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t al., 2019; </a:t>
                      </a:r>
                      <a:r>
                        <a:rPr lang="fr-BE" sz="9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etitpré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t al., 2018; Wende et al., 2012; </a:t>
                      </a:r>
                      <a:r>
                        <a:rPr lang="fr-BE" sz="9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Zeisel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t al., </a:t>
                      </a:r>
                      <a:r>
                        <a:rPr lang="fr-BE" sz="9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18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9026893"/>
                  </a:ext>
                </a:extLst>
              </a:tr>
              <a:tr h="260408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fA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N.D.</a:t>
                      </a:r>
                      <a:endParaRPr lang="fr-FR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.D.</a:t>
                      </a:r>
                      <a:endParaRPr lang="fr-FR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.D.</a:t>
                      </a:r>
                      <a:endParaRPr lang="fr-FR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? 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∞</a:t>
                      </a:r>
                      <a:endParaRPr lang="fr-FR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.D. </a:t>
                      </a:r>
                      <a:endParaRPr lang="fr-FR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.D.</a:t>
                      </a:r>
                      <a:endParaRPr lang="fr-FR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.D.</a:t>
                      </a:r>
                      <a:endParaRPr lang="fr-FR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11 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BE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P15</a:t>
                      </a:r>
                      <a:endParaRPr lang="fr-FR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43" marR="653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0160128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477848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245748" y="445163"/>
            <a:ext cx="9700505" cy="1475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S1. Expression profile of some genes encoding transcription factors controlling neurogenesis and neuronal diversification in mouse sensory ganglia.</a:t>
            </a:r>
            <a:r>
              <a:rPr lang="fr-FR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color code is associated with the neuron type in which the transcription factors has been detected by immunofluorescence assays : </a:t>
            </a:r>
            <a:r>
              <a:rPr lang="en-US" sz="1200" b="1" dirty="0">
                <a:solidFill>
                  <a:srgbClr val="0070C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chano- and/or proprioceptors</a:t>
            </a:r>
            <a:r>
              <a:rPr lang="en-US" sz="1200" dirty="0">
                <a:solidFill>
                  <a:srgbClr val="0070C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in light blue), </a:t>
            </a:r>
            <a:r>
              <a:rPr lang="en-US" sz="1200" b="1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ciceptive neurons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in red), </a:t>
            </a:r>
            <a:r>
              <a:rPr lang="en-US" sz="1200" b="1" dirty="0">
                <a:solidFill>
                  <a:srgbClr val="2F5496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l somatosensory neuron types</a:t>
            </a:r>
            <a:r>
              <a:rPr lang="en-US" sz="1200" dirty="0">
                <a:solidFill>
                  <a:srgbClr val="2F5496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dark blue), </a:t>
            </a:r>
            <a:r>
              <a:rPr lang="en-US" sz="1200" b="1" dirty="0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isceral sensory neurons</a:t>
            </a:r>
            <a:r>
              <a:rPr lang="en-US" sz="1200" dirty="0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green). Part of the information about their expression in ganglia of adult mice derives from single cell RNA-seq studies (see references in the text). Abbreviations:</a:t>
            </a:r>
            <a:r>
              <a:rPr lang="fr-F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: Trigeminal ganglia ;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: Geniculate ganglia ;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: Cochlear ganglia ;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: Vestibular ganglia ;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N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: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tros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– Nodose ganglia ;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J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: Superior – Jugular ganglia ;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R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: Dorsal root ganglia ;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.D.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: Not determined ;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X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Wingdings" panose="05000000000000000000" pitchFamily="2" charset="2"/>
              </a:rPr>
              <a:t>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Y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: expression from stage X until Y ;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lt; EX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: earlier than stage X ;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No expression reported ;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∞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: expression in adult tissue ;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~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: approximately</a:t>
            </a:r>
            <a:endParaRPr lang="fr-FR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750634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41</TotalTime>
  <Words>883</Words>
  <Application>Microsoft Office PowerPoint</Application>
  <PresentationFormat>Grand écran</PresentationFormat>
  <Paragraphs>210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Wingdings</vt:lpstr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imon Desiderio</dc:creator>
  <cp:lastModifiedBy>Simon Desiderio</cp:lastModifiedBy>
  <cp:revision>10</cp:revision>
  <dcterms:created xsi:type="dcterms:W3CDTF">2020-07-13T07:57:48Z</dcterms:created>
  <dcterms:modified xsi:type="dcterms:W3CDTF">2020-07-24T08:29:01Z</dcterms:modified>
</cp:coreProperties>
</file>